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1844824"/>
            <a:ext cx="6577584" cy="161544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67544" y="3717032"/>
            <a:ext cx="8352928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.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olymerase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hain reaction (PCR) amplification of genomic DNA of autotetraploid rice hybrids using a marker G02-69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anes 1 and 2 indicate the genotype of Taichung65-4x and E25-4x, Lanes 3-12 the genotypes of F</a:t>
            </a:r>
            <a:r>
              <a:rPr lang="en-US" altLang="zh-CN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hybrid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Taichung65-4x×E25-4x), which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under the interaction of </a:t>
            </a:r>
            <a:r>
              <a:rPr lang="en-US" altLang="zh-CN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a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b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ollen sterility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oci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28285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7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4</cp:revision>
  <dcterms:modified xsi:type="dcterms:W3CDTF">2017-10-19T07:30:51Z</dcterms:modified>
</cp:coreProperties>
</file>